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8"/>
    <p:restoredTop sz="94698"/>
  </p:normalViewPr>
  <p:slideViewPr>
    <p:cSldViewPr snapToGrid="0" snapToObjects="1">
      <p:cViewPr varScale="1">
        <p:scale>
          <a:sx n="221" d="100"/>
          <a:sy n="221" d="100"/>
        </p:scale>
        <p:origin x="14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743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071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552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374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808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252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298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579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81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34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29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C0F87-651B-8546-A7FB-EFFC054D035B}" type="datetimeFigureOut">
              <a:rPr lang="en-US" smtClean="0"/>
              <a:t>10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5BBC7-CD71-1A43-9027-04CEE66D5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545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4997088-7A81-C748-B4D6-ED8C090943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315" t="16245" r="19209" b="25364"/>
          <a:stretch/>
        </p:blipFill>
        <p:spPr>
          <a:xfrm>
            <a:off x="1471449" y="1250731"/>
            <a:ext cx="5633546" cy="400444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5FA2DD7-7520-A74A-8A26-45D0751140AB}"/>
              </a:ext>
            </a:extLst>
          </p:cNvPr>
          <p:cNvSpPr/>
          <p:nvPr/>
        </p:nvSpPr>
        <p:spPr>
          <a:xfrm>
            <a:off x="3216165" y="2060027"/>
            <a:ext cx="2606565" cy="1576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D3CF8D7-545C-C747-8912-8D10DD5E27AD}"/>
              </a:ext>
            </a:extLst>
          </p:cNvPr>
          <p:cNvSpPr txBox="1"/>
          <p:nvPr/>
        </p:nvSpPr>
        <p:spPr>
          <a:xfrm>
            <a:off x="1596573" y="5602804"/>
            <a:ext cx="56533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Sequence comparison of two S-type LMW-GS. 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olyQ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gion that distinguishes the two proteins is shown in the red box.</a:t>
            </a:r>
          </a:p>
        </p:txBody>
      </p:sp>
    </p:spTree>
    <p:extLst>
      <p:ext uri="{BB962C8B-B14F-4D97-AF65-F5344CB8AC3E}">
        <p14:creationId xmlns:p14="http://schemas.microsoft.com/office/powerpoint/2010/main" val="1580946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tenbach, Susan - ARS</dc:creator>
  <cp:lastModifiedBy>Altenbach, Susan - ARS</cp:lastModifiedBy>
  <cp:revision>4</cp:revision>
  <cp:lastPrinted>2018-09-28T23:59:54Z</cp:lastPrinted>
  <dcterms:created xsi:type="dcterms:W3CDTF">2018-09-28T23:57:51Z</dcterms:created>
  <dcterms:modified xsi:type="dcterms:W3CDTF">2018-10-26T19:31:09Z</dcterms:modified>
</cp:coreProperties>
</file>